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8046" autoAdjust="0"/>
  </p:normalViewPr>
  <p:slideViewPr>
    <p:cSldViewPr>
      <p:cViewPr>
        <p:scale>
          <a:sx n="90" d="100"/>
          <a:sy n="90" d="100"/>
        </p:scale>
        <p:origin x="-1963" y="-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49048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23390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8228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1603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6058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1129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4316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8295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0609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3367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4957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A22DB-FE27-4E18-A8DE-569594A9942F}" type="datetimeFigureOut">
              <a:rPr lang="it-IT" smtClean="0"/>
              <a:t>18/07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4C6C2-9382-499B-BBE6-03AE5FB7D7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3731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uppo 23"/>
          <p:cNvGrpSpPr/>
          <p:nvPr/>
        </p:nvGrpSpPr>
        <p:grpSpPr>
          <a:xfrm>
            <a:off x="1825401" y="395537"/>
            <a:ext cx="2824411" cy="3240359"/>
            <a:chOff x="1543784" y="1783353"/>
            <a:chExt cx="2670554" cy="4149273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4"/>
            <a:stretch/>
          </p:blipFill>
          <p:spPr bwMode="auto">
            <a:xfrm>
              <a:off x="2089151" y="2089487"/>
              <a:ext cx="2125187" cy="38431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1" name="Gruppo 10"/>
            <p:cNvGrpSpPr/>
            <p:nvPr/>
          </p:nvGrpSpPr>
          <p:grpSpPr>
            <a:xfrm>
              <a:off x="1688751" y="2996952"/>
              <a:ext cx="562547" cy="2880876"/>
              <a:chOff x="1564926" y="2124639"/>
              <a:chExt cx="562547" cy="2880876"/>
            </a:xfrm>
          </p:grpSpPr>
          <p:sp>
            <p:nvSpPr>
              <p:cNvPr id="12" name="CasellaDiTesto 11"/>
              <p:cNvSpPr txBox="1"/>
              <p:nvPr/>
            </p:nvSpPr>
            <p:spPr>
              <a:xfrm>
                <a:off x="1564926" y="2124639"/>
                <a:ext cx="408021" cy="3152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7.4</a:t>
                </a:r>
                <a:endParaRPr lang="it-IT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CasellaDiTesto 12"/>
              <p:cNvSpPr txBox="1"/>
              <p:nvPr/>
            </p:nvSpPr>
            <p:spPr>
              <a:xfrm>
                <a:off x="1564926" y="2646138"/>
                <a:ext cx="408021" cy="3152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6.2</a:t>
                </a:r>
                <a:endParaRPr lang="it-IT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CasellaDiTesto 13"/>
              <p:cNvSpPr txBox="1"/>
              <p:nvPr/>
            </p:nvSpPr>
            <p:spPr>
              <a:xfrm>
                <a:off x="1693166" y="3409948"/>
                <a:ext cx="434307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  <a:endParaRPr lang="it-IT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CasellaDiTesto 14"/>
              <p:cNvSpPr txBox="1"/>
              <p:nvPr/>
            </p:nvSpPr>
            <p:spPr>
              <a:xfrm>
                <a:off x="1693166" y="4038970"/>
                <a:ext cx="434307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1</a:t>
                </a:r>
                <a:endParaRPr lang="it-IT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CasellaDiTesto 15"/>
              <p:cNvSpPr txBox="1"/>
              <p:nvPr/>
            </p:nvSpPr>
            <p:spPr>
              <a:xfrm>
                <a:off x="1564926" y="4534950"/>
                <a:ext cx="408021" cy="3152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1.5</a:t>
                </a:r>
                <a:endParaRPr lang="it-IT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CasellaDiTesto 16"/>
              <p:cNvSpPr txBox="1"/>
              <p:nvPr/>
            </p:nvSpPr>
            <p:spPr>
              <a:xfrm>
                <a:off x="1693166" y="4820849"/>
                <a:ext cx="434307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lang="it-IT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" name="CasellaDiTesto 17"/>
            <p:cNvSpPr txBox="1"/>
            <p:nvPr/>
          </p:nvSpPr>
          <p:spPr>
            <a:xfrm>
              <a:off x="1543784" y="2073585"/>
              <a:ext cx="673689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W</a:t>
              </a:r>
            </a:p>
            <a:p>
              <a:pPr algn="ctr"/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t-IT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3008242" y="1783353"/>
              <a:ext cx="418632" cy="315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µ</a:t>
              </a:r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3445194" y="1785534"/>
              <a:ext cx="523213" cy="3152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5 µg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CasellaDiTesto 19"/>
          <p:cNvSpPr txBox="1"/>
          <p:nvPr/>
        </p:nvSpPr>
        <p:spPr>
          <a:xfrm>
            <a:off x="396454" y="4324077"/>
            <a:ext cx="604867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SDS-PAGE under reducing condition analysis (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omassie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illiant blue staining) 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uma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ERα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 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 ER-positive breast cancer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s: 1, molecular weigh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s (MW);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 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µg anti-ERα Abs; 3, 0.5 µ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ERα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59118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1466924" y="1167706"/>
            <a:ext cx="3330228" cy="3188270"/>
            <a:chOff x="1268760" y="2401398"/>
            <a:chExt cx="3330228" cy="3188270"/>
          </a:xfrm>
        </p:grpSpPr>
        <p:graphicFrame>
          <p:nvGraphicFramePr>
            <p:cNvPr id="5" name="Oggetto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30065868"/>
                </p:ext>
              </p:extLst>
            </p:nvPr>
          </p:nvGraphicFramePr>
          <p:xfrm>
            <a:off x="1466850" y="2500313"/>
            <a:ext cx="3132138" cy="21955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Prism Project" r:id="rId3" imgW="3132000" imgH="2196000" progId="Prism5.Document">
                    <p:embed/>
                  </p:oleObj>
                </mc:Choice>
                <mc:Fallback>
                  <p:oleObj name="Prism Project" r:id="rId3" imgW="3132000" imgH="21960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466850" y="2500313"/>
                          <a:ext cx="3132138" cy="21955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CasellaDiTesto 5"/>
            <p:cNvSpPr txBox="1"/>
            <p:nvPr/>
          </p:nvSpPr>
          <p:spPr>
            <a:xfrm rot="16200000">
              <a:off x="550935" y="3561633"/>
              <a:ext cx="16818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% of Ki-67-positive </a:t>
              </a:r>
              <a:r>
                <a:rPr lang="it-IT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7" name="CasellaDiTesto 6"/>
            <p:cNvSpPr txBox="1"/>
            <p:nvPr/>
          </p:nvSpPr>
          <p:spPr>
            <a:xfrm rot="18600000">
              <a:off x="1571053" y="4763751"/>
              <a:ext cx="8513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CasellaDiTesto 7"/>
            <p:cNvSpPr txBox="1"/>
            <p:nvPr/>
          </p:nvSpPr>
          <p:spPr>
            <a:xfrm rot="18600000">
              <a:off x="2424280" y="4559447"/>
              <a:ext cx="4805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2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CasellaDiTesto 8"/>
            <p:cNvSpPr txBox="1"/>
            <p:nvPr/>
          </p:nvSpPr>
          <p:spPr>
            <a:xfrm rot="18600000">
              <a:off x="2494150" y="4707944"/>
              <a:ext cx="1209451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2+ anti-ER</a:t>
              </a:r>
              <a:r>
                <a:rPr lang="el-GR" sz="1000" b="1" dirty="0" smtClean="0">
                  <a:latin typeface="Arial"/>
                  <a:cs typeface="Arial"/>
                </a:rPr>
                <a:t>α</a:t>
              </a:r>
              <a:r>
                <a:rPr lang="it-IT" sz="1000" b="1" dirty="0" smtClean="0">
                  <a:latin typeface="Arial"/>
                  <a:cs typeface="Arial"/>
                </a:rPr>
                <a:t> </a:t>
              </a:r>
              <a:r>
                <a:rPr lang="it-IT" sz="1000" b="1" dirty="0" err="1" smtClean="0">
                  <a:latin typeface="Arial"/>
                  <a:cs typeface="Arial"/>
                </a:rPr>
                <a:t>Abs</a:t>
              </a:r>
              <a:endParaRPr lang="it-IT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CasellaDiTesto 9"/>
            <p:cNvSpPr txBox="1"/>
            <p:nvPr/>
          </p:nvSpPr>
          <p:spPr>
            <a:xfrm rot="18600000">
              <a:off x="3136447" y="4711496"/>
              <a:ext cx="8550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2+ TAM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CasellaDiTesto 10"/>
            <p:cNvSpPr txBox="1"/>
            <p:nvPr/>
          </p:nvSpPr>
          <p:spPr>
            <a:xfrm rot="18600000">
              <a:off x="3515389" y="4769955"/>
              <a:ext cx="107939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2+ anti-ER</a:t>
              </a:r>
              <a:r>
                <a:rPr lang="el-GR" sz="1000" b="1" dirty="0" smtClean="0">
                  <a:latin typeface="Arial"/>
                  <a:cs typeface="Arial"/>
                </a:rPr>
                <a:t>α</a:t>
              </a:r>
              <a:r>
                <a:rPr lang="it-IT" sz="1000" b="1" dirty="0" smtClean="0">
                  <a:latin typeface="Arial"/>
                  <a:cs typeface="Arial"/>
                </a:rPr>
                <a:t> </a:t>
              </a:r>
              <a:r>
                <a:rPr lang="it-IT" sz="1000" b="1" dirty="0" err="1" smtClean="0">
                  <a:latin typeface="Arial"/>
                  <a:cs typeface="Arial"/>
                </a:rPr>
                <a:t>Abs</a:t>
              </a:r>
              <a:r>
                <a:rPr lang="it-IT" sz="1000" b="1" dirty="0" smtClean="0">
                  <a:latin typeface="Arial"/>
                  <a:cs typeface="Arial"/>
                </a:rPr>
                <a:t>+ TAM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Connettore 1 11"/>
            <p:cNvCxnSpPr/>
            <p:nvPr/>
          </p:nvCxnSpPr>
          <p:spPr>
            <a:xfrm flipV="1">
              <a:off x="2109106" y="3169344"/>
              <a:ext cx="0" cy="28803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ttore 1 12"/>
            <p:cNvCxnSpPr/>
            <p:nvPr/>
          </p:nvCxnSpPr>
          <p:spPr>
            <a:xfrm flipV="1">
              <a:off x="2640810" y="3169344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ttore 1 13"/>
            <p:cNvCxnSpPr/>
            <p:nvPr/>
          </p:nvCxnSpPr>
          <p:spPr>
            <a:xfrm>
              <a:off x="2109106" y="3169344"/>
              <a:ext cx="5317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ttore 1 14"/>
            <p:cNvCxnSpPr/>
            <p:nvPr/>
          </p:nvCxnSpPr>
          <p:spPr>
            <a:xfrm flipV="1">
              <a:off x="2084598" y="2654929"/>
              <a:ext cx="0" cy="3225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ttore 1 15"/>
            <p:cNvCxnSpPr/>
            <p:nvPr/>
          </p:nvCxnSpPr>
          <p:spPr>
            <a:xfrm>
              <a:off x="2084598" y="2654929"/>
              <a:ext cx="15031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ttore 1 16"/>
            <p:cNvCxnSpPr/>
            <p:nvPr/>
          </p:nvCxnSpPr>
          <p:spPr>
            <a:xfrm>
              <a:off x="3587702" y="2654929"/>
              <a:ext cx="0" cy="50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CasellaDiTesto 17"/>
            <p:cNvSpPr txBox="1"/>
            <p:nvPr/>
          </p:nvSpPr>
          <p:spPr>
            <a:xfrm>
              <a:off x="2248749" y="2935171"/>
              <a:ext cx="255198" cy="2312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2699994" y="2401398"/>
              <a:ext cx="325730" cy="2543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it-IT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Connettore 1 19"/>
            <p:cNvCxnSpPr/>
            <p:nvPr/>
          </p:nvCxnSpPr>
          <p:spPr>
            <a:xfrm>
              <a:off x="3635960" y="3131082"/>
              <a:ext cx="0" cy="2535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1 20"/>
            <p:cNvCxnSpPr/>
            <p:nvPr/>
          </p:nvCxnSpPr>
          <p:spPr>
            <a:xfrm>
              <a:off x="3635558" y="3131082"/>
              <a:ext cx="50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1 21"/>
            <p:cNvCxnSpPr/>
            <p:nvPr/>
          </p:nvCxnSpPr>
          <p:spPr>
            <a:xfrm>
              <a:off x="4143454" y="3131082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CasellaDiTesto 22"/>
            <p:cNvSpPr txBox="1"/>
            <p:nvPr/>
          </p:nvSpPr>
          <p:spPr>
            <a:xfrm>
              <a:off x="3716718" y="2905535"/>
              <a:ext cx="396262" cy="2312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it-IT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4" name="Connettore 1 23"/>
          <p:cNvCxnSpPr/>
          <p:nvPr/>
        </p:nvCxnSpPr>
        <p:spPr>
          <a:xfrm flipV="1">
            <a:off x="2849038" y="1653154"/>
            <a:ext cx="0" cy="2062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ttore 1 24"/>
          <p:cNvCxnSpPr/>
          <p:nvPr/>
        </p:nvCxnSpPr>
        <p:spPr>
          <a:xfrm flipV="1">
            <a:off x="3392617" y="1654472"/>
            <a:ext cx="0" cy="10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CasellaDiTesto 25"/>
          <p:cNvSpPr txBox="1"/>
          <p:nvPr/>
        </p:nvSpPr>
        <p:spPr>
          <a:xfrm>
            <a:off x="3015731" y="1467809"/>
            <a:ext cx="255198" cy="1911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it-I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Connettore 1 26"/>
          <p:cNvCxnSpPr/>
          <p:nvPr/>
        </p:nvCxnSpPr>
        <p:spPr>
          <a:xfrm>
            <a:off x="2849038" y="1653979"/>
            <a:ext cx="54397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asellaDiTesto 1"/>
          <p:cNvSpPr txBox="1"/>
          <p:nvPr/>
        </p:nvSpPr>
        <p:spPr>
          <a:xfrm>
            <a:off x="188640" y="5076055"/>
            <a:ext cx="655272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proliferatio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MCF-7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treate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E2 or E2 plus 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ERα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, in presence or absence of tamoxife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el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liferat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evaluat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flow cytometr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-67 nuclear antigen expression in MCF-7 cells treated or not for 24 hours wit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2 (10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E2 + anti-ERα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 (50 µg/ml)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2 + TAM 1µM, E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anti-ER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TAM. Data report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mean ± SD (right), *, P &lt; 0.05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**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; ***, P&lt;0.001,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Student’s t tes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00052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178</Words>
  <Application>Microsoft Office PowerPoint</Application>
  <PresentationFormat>Presentazione su schermo (4:3)</PresentationFormat>
  <Paragraphs>22</Paragraphs>
  <Slides>2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4" baseType="lpstr">
      <vt:lpstr>Tema di Office</vt:lpstr>
      <vt:lpstr>Prism Projec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omune</dc:creator>
  <cp:lastModifiedBy>Ortona Elena</cp:lastModifiedBy>
  <cp:revision>16</cp:revision>
  <dcterms:created xsi:type="dcterms:W3CDTF">2019-07-10T13:40:04Z</dcterms:created>
  <dcterms:modified xsi:type="dcterms:W3CDTF">2019-07-18T14:24:50Z</dcterms:modified>
</cp:coreProperties>
</file>